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14" autoAdjust="0"/>
    <p:restoredTop sz="94660"/>
  </p:normalViewPr>
  <p:slideViewPr>
    <p:cSldViewPr snapToGrid="0">
      <p:cViewPr varScale="1">
        <p:scale>
          <a:sx n="78" d="100"/>
          <a:sy n="78" d="100"/>
        </p:scale>
        <p:origin x="102" y="1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88B47B-2E78-4745-A94F-3AC204F307B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012748F-D601-46D0-AF78-E0E44B17222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3A44D5-3A2A-4FAB-B4A2-0A9B1AA518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6C907-2D24-4A51-B071-C76C15563CC8}" type="datetimeFigureOut">
              <a:rPr lang="en-GB" smtClean="0"/>
              <a:t>21/04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AE65D2-A501-4806-A55A-F4AA3C1198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575A84-0F58-475D-AF80-EA6F721AF7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C5FD7-D896-450F-B350-5D4C4BCE57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49013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D2B598-94BA-4651-8B24-EE977E9E77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70D2ABA-EA2C-4C9D-8D5A-D5EF3F7220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913D8B-FE45-4C98-90DA-B8DCC4D6F3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6C907-2D24-4A51-B071-C76C15563CC8}" type="datetimeFigureOut">
              <a:rPr lang="en-GB" smtClean="0"/>
              <a:t>21/04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F1D420-A750-4ADC-A9D8-10B7A545BF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312A45-B94C-4D2D-A8DC-6F34766D51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C5FD7-D896-450F-B350-5D4C4BCE57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23719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B494805-EF2E-4E2E-B81E-0E3701AEE76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0DABDD2-5CA6-4162-A771-07FB2A3C007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7C2ABB6-E8B4-4ACC-890D-E80797DE23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6C907-2D24-4A51-B071-C76C15563CC8}" type="datetimeFigureOut">
              <a:rPr lang="en-GB" smtClean="0"/>
              <a:t>21/04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A3495F-51FA-42AE-99F8-12CDD8287E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BD2FED-FA93-493C-B3AF-0F7991CE34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C5FD7-D896-450F-B350-5D4C4BCE57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61878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8065CE-BAFD-43B8-A0D4-15E0AE55AF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CC80716-09C2-4602-9CDC-82CC243B57F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5A4C07-3021-4478-876B-A943A94548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6C907-2D24-4A51-B071-C76C15563CC8}" type="datetimeFigureOut">
              <a:rPr lang="en-GB" smtClean="0"/>
              <a:t>21/04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529501-0FA5-4BAA-9121-43CB9CAAED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07BFE5-E5CD-4E11-909D-EF019A85CC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C5FD7-D896-450F-B350-5D4C4BCE57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53399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4897EA-FD96-435D-A995-1F394F29D2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D725BF8-A82C-4F7A-A197-27EAE45FA6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C3FDF4-7E87-4274-8BB3-60A20A70F9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6C907-2D24-4A51-B071-C76C15563CC8}" type="datetimeFigureOut">
              <a:rPr lang="en-GB" smtClean="0"/>
              <a:t>21/04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07E563-9F10-44AA-A33D-379E127451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A7806F-3E6C-4D95-8C5D-DA5DBB9C2A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C5FD7-D896-450F-B350-5D4C4BCE57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23896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A7BCF2-3F19-44C6-90BD-2B19591455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DB148BB-80E7-4A24-9325-AB3A6D4B3A9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65CB3E6-A03F-4004-BF70-8FD1D5CA57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21F99BD-B0C6-4F46-B476-8ECA8A3B1B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6C907-2D24-4A51-B071-C76C15563CC8}" type="datetimeFigureOut">
              <a:rPr lang="en-GB" smtClean="0"/>
              <a:t>21/04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7C68B56-B72A-4207-9F54-2A8B1BC05A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22806A-A00C-4E74-AFD1-3A25C740DA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C5FD7-D896-450F-B350-5D4C4BCE57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9108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9923A8-4478-4350-B6B7-3EBE4B464A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0DB09EF-0101-4439-9D11-E5CB798C76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9861B6E-047A-41EF-914A-49941A8601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22F83EE-5625-48DC-910C-EEC720E27D6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C6A6A27-7A7F-4F8E-9D00-05CCC46136A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E24FDF4-4CB0-46CD-9E21-A7264127D0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6C907-2D24-4A51-B071-C76C15563CC8}" type="datetimeFigureOut">
              <a:rPr lang="en-GB" smtClean="0"/>
              <a:t>21/04/2020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0C0B1BA-3011-4CD1-A708-E7E29E3919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AB09CFB-558B-4C8A-8E96-ADB84795EE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C5FD7-D896-450F-B350-5D4C4BCE57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11521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E61EC5-C9F6-4079-856A-3A9A2ADEFB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E846160-1F4F-4262-9C94-37A2C5C6BA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6C907-2D24-4A51-B071-C76C15563CC8}" type="datetimeFigureOut">
              <a:rPr lang="en-GB" smtClean="0"/>
              <a:t>21/04/2020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FCBF484-8332-4C5E-AA3F-C2DBF13883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4188F37-8BF5-43C9-A58E-194F168034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C5FD7-D896-450F-B350-5D4C4BCE57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33694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3495D56-4A98-4F51-8E68-212B8D83B0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6C907-2D24-4A51-B071-C76C15563CC8}" type="datetimeFigureOut">
              <a:rPr lang="en-GB" smtClean="0"/>
              <a:t>21/04/2020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1720CE2-F8B7-43F4-A4C1-6045821CBF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D080271-BA58-4290-A54A-AF02C60CD5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C5FD7-D896-450F-B350-5D4C4BCE57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50632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F18DC2-4E52-48DF-8877-C34CD3B570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A738F18-69CA-4C7F-B435-6B3A3E78D92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11C774D-78F0-4E34-8001-F1D64839E96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163EEDD-8F4F-4368-83FA-18171F139B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6C907-2D24-4A51-B071-C76C15563CC8}" type="datetimeFigureOut">
              <a:rPr lang="en-GB" smtClean="0"/>
              <a:t>21/04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85D4E45-B76F-4586-B626-498918B9F6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34FC1E9-C370-47F5-A3E6-72E61F079F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C5FD7-D896-450F-B350-5D4C4BCE57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17374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7D190D-F754-4248-B830-DFA30B973D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4B972C9-671B-4F00-B2A5-28790CF1348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CBEC7B8-80D7-433A-B3DC-6844F3E2378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E7B79B8-42AB-45CC-9FE1-F849DE01BD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6C907-2D24-4A51-B071-C76C15563CC8}" type="datetimeFigureOut">
              <a:rPr lang="en-GB" smtClean="0"/>
              <a:t>21/04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7F35E63-59CE-47F2-8D79-DDA7DA8472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FF5FC4F-E890-4FF1-8DFC-1AFDFA8359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C5FD7-D896-450F-B350-5D4C4BCE57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98138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0F09438-2FCD-44B2-B5D0-B79654D625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562A748-0179-4E8F-98A8-173380E250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F7B69A-D8E2-4920-A1C0-A0510EBF7B0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76C907-2D24-4A51-B071-C76C15563CC8}" type="datetimeFigureOut">
              <a:rPr lang="en-GB" smtClean="0"/>
              <a:t>21/04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DAD0C0-A593-4439-8A9A-24DE9AEE85D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16E9A5-7800-480A-8B66-EFA5D141DA7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DC5FD7-D896-450F-B350-5D4C4BCE57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25597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"/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D13D25FC-1D36-45B3-AD47-B811E6FFDB2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6204" y="2202759"/>
            <a:ext cx="4206840" cy="1289661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F5C3BC35-0239-4495-92AA-98F6C5D643C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52090" y="3576309"/>
            <a:ext cx="4146180" cy="1708754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DC853533-0BEA-4617-9ECD-448CD0D7273F}"/>
              </a:ext>
            </a:extLst>
          </p:cNvPr>
          <p:cNvSpPr txBox="1"/>
          <p:nvPr/>
        </p:nvSpPr>
        <p:spPr>
          <a:xfrm rot="18921849">
            <a:off x="1193019" y="1507241"/>
            <a:ext cx="15519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BF0E622-1880-4998-AE12-C5A41B4D63D0}"/>
              </a:ext>
            </a:extLst>
          </p:cNvPr>
          <p:cNvSpPr txBox="1"/>
          <p:nvPr/>
        </p:nvSpPr>
        <p:spPr>
          <a:xfrm rot="18921849">
            <a:off x="1833642" y="1507240"/>
            <a:ext cx="15519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EXOSC9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0C21D5E-C7B9-4706-838C-868E6DAB9F22}"/>
              </a:ext>
            </a:extLst>
          </p:cNvPr>
          <p:cNvSpPr txBox="1"/>
          <p:nvPr/>
        </p:nvSpPr>
        <p:spPr>
          <a:xfrm rot="18921849">
            <a:off x="1513331" y="1507241"/>
            <a:ext cx="15519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EXOSC9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A948152-2259-4935-952B-CB4F172C078F}"/>
              </a:ext>
            </a:extLst>
          </p:cNvPr>
          <p:cNvSpPr txBox="1"/>
          <p:nvPr/>
        </p:nvSpPr>
        <p:spPr>
          <a:xfrm>
            <a:off x="4585179" y="2478257"/>
            <a:ext cx="10102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Karyo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7E9395F-EB05-43E2-B2D4-14AFE710F500}"/>
              </a:ext>
            </a:extLst>
          </p:cNvPr>
          <p:cNvSpPr txBox="1"/>
          <p:nvPr/>
        </p:nvSpPr>
        <p:spPr>
          <a:xfrm>
            <a:off x="4649112" y="2847589"/>
            <a:ext cx="1343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EXOSC9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9B38103-465E-4FEF-B4DB-50A222D31B84}"/>
              </a:ext>
            </a:extLst>
          </p:cNvPr>
          <p:cNvSpPr txBox="1"/>
          <p:nvPr/>
        </p:nvSpPr>
        <p:spPr>
          <a:xfrm>
            <a:off x="4998270" y="3664150"/>
            <a:ext cx="1343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EXOSC8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64F133F7-3712-4BD5-BB98-93D0E18DE68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86470" y="2202759"/>
            <a:ext cx="4811097" cy="3113053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0C9CBE54-CB57-46F6-8A83-39ED65F56D6B}"/>
              </a:ext>
            </a:extLst>
          </p:cNvPr>
          <p:cNvSpPr txBox="1"/>
          <p:nvPr/>
        </p:nvSpPr>
        <p:spPr>
          <a:xfrm rot="18921849">
            <a:off x="8868016" y="1444497"/>
            <a:ext cx="15519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0951491-7EEB-41BC-B207-501D68F9778C}"/>
              </a:ext>
            </a:extLst>
          </p:cNvPr>
          <p:cNvSpPr txBox="1"/>
          <p:nvPr/>
        </p:nvSpPr>
        <p:spPr>
          <a:xfrm rot="18921849">
            <a:off x="9508639" y="1394162"/>
            <a:ext cx="15519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EXOSC9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E592DAB-0956-4600-BC82-FC55DAA7D6A5}"/>
              </a:ext>
            </a:extLst>
          </p:cNvPr>
          <p:cNvSpPr txBox="1"/>
          <p:nvPr/>
        </p:nvSpPr>
        <p:spPr>
          <a:xfrm rot="18921849">
            <a:off x="9188328" y="1394163"/>
            <a:ext cx="15519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EXOSC9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A631916-375A-4910-BFF5-AD9040295602}"/>
              </a:ext>
            </a:extLst>
          </p:cNvPr>
          <p:cNvSpPr txBox="1"/>
          <p:nvPr/>
        </p:nvSpPr>
        <p:spPr>
          <a:xfrm>
            <a:off x="10995145" y="2538378"/>
            <a:ext cx="10102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Karyo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0427E2C-D509-4A0E-8691-4A7AA2B7BD9B}"/>
              </a:ext>
            </a:extLst>
          </p:cNvPr>
          <p:cNvSpPr txBox="1"/>
          <p:nvPr/>
        </p:nvSpPr>
        <p:spPr>
          <a:xfrm>
            <a:off x="10995145" y="3059668"/>
            <a:ext cx="792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p53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724899D-E856-42B1-9170-E47500591354}"/>
              </a:ext>
            </a:extLst>
          </p:cNvPr>
          <p:cNvSpPr txBox="1"/>
          <p:nvPr/>
        </p:nvSpPr>
        <p:spPr>
          <a:xfrm>
            <a:off x="2105164" y="199135"/>
            <a:ext cx="87511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EXOSC8 and 9 blot (Figure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5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) on the left and loading control and p53 on the right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C61FE4F3-D481-4E7E-A5D0-7B413E8C9F73}"/>
              </a:ext>
            </a:extLst>
          </p:cNvPr>
          <p:cNvSpPr/>
          <p:nvPr/>
        </p:nvSpPr>
        <p:spPr>
          <a:xfrm>
            <a:off x="8939134" y="2183884"/>
            <a:ext cx="1018597" cy="311305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8B1CB3DF-D692-40C1-BF0E-028B43DBF04E}"/>
              </a:ext>
            </a:extLst>
          </p:cNvPr>
          <p:cNvSpPr/>
          <p:nvPr/>
        </p:nvSpPr>
        <p:spPr>
          <a:xfrm>
            <a:off x="1199624" y="2355159"/>
            <a:ext cx="1182849" cy="311305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06937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8C9B8A0A-4DE8-45E3-B039-D46EEA3434A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3895" y="2093461"/>
            <a:ext cx="3842499" cy="3374296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435EB6B-DD79-446C-8A04-0E4E67ED11D5}"/>
              </a:ext>
            </a:extLst>
          </p:cNvPr>
          <p:cNvSpPr txBox="1"/>
          <p:nvPr/>
        </p:nvSpPr>
        <p:spPr>
          <a:xfrm>
            <a:off x="2105164" y="199135"/>
            <a:ext cx="79816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EXOSC9 blot (</a:t>
            </a:r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mtClean="0">
                <a:latin typeface="Arial" panose="020B0604020202020204" pitchFamily="34" charset="0"/>
                <a:cs typeface="Arial" panose="020B0604020202020204" pitchFamily="34" charset="0"/>
              </a:rPr>
              <a:t>5B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) on the left and loading control and p53 on the right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F7F45AE1-1754-4C08-8AEE-0156F066F0B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21886" y="2191425"/>
            <a:ext cx="4425307" cy="3374296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C862A932-D5B4-4D2B-A560-EF7EF3D410E4}"/>
              </a:ext>
            </a:extLst>
          </p:cNvPr>
          <p:cNvSpPr txBox="1"/>
          <p:nvPr/>
        </p:nvSpPr>
        <p:spPr>
          <a:xfrm rot="18921849">
            <a:off x="1469856" y="1568742"/>
            <a:ext cx="15519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A3955C4-F108-4F1F-A101-DDA16EB6EACC}"/>
              </a:ext>
            </a:extLst>
          </p:cNvPr>
          <p:cNvSpPr txBox="1"/>
          <p:nvPr/>
        </p:nvSpPr>
        <p:spPr>
          <a:xfrm rot="18921849">
            <a:off x="2029161" y="1531400"/>
            <a:ext cx="15519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RPL5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24203CA-7F4C-44E9-AA45-082264EB9E94}"/>
              </a:ext>
            </a:extLst>
          </p:cNvPr>
          <p:cNvSpPr txBox="1"/>
          <p:nvPr/>
        </p:nvSpPr>
        <p:spPr>
          <a:xfrm rot="18921849">
            <a:off x="2517122" y="1531401"/>
            <a:ext cx="15519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EXOSC9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B04E727-5B50-4639-8172-8C59EB3554A6}"/>
              </a:ext>
            </a:extLst>
          </p:cNvPr>
          <p:cNvSpPr txBox="1"/>
          <p:nvPr/>
        </p:nvSpPr>
        <p:spPr>
          <a:xfrm rot="18921849">
            <a:off x="3076427" y="1494059"/>
            <a:ext cx="15519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EXOSC9-L5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16FAAB2-6D38-4B4E-8EF5-DA69B8041B6E}"/>
              </a:ext>
            </a:extLst>
          </p:cNvPr>
          <p:cNvSpPr txBox="1"/>
          <p:nvPr/>
        </p:nvSpPr>
        <p:spPr>
          <a:xfrm rot="18921849">
            <a:off x="7268046" y="1606083"/>
            <a:ext cx="15519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510985F-22CE-4BB5-A1BF-F442AD6EEA5C}"/>
              </a:ext>
            </a:extLst>
          </p:cNvPr>
          <p:cNvSpPr txBox="1"/>
          <p:nvPr/>
        </p:nvSpPr>
        <p:spPr>
          <a:xfrm rot="18921849">
            <a:off x="7827351" y="1568741"/>
            <a:ext cx="15519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RPL5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CDDC13E-37F3-4F86-BC97-FA7E88B88DDC}"/>
              </a:ext>
            </a:extLst>
          </p:cNvPr>
          <p:cNvSpPr txBox="1"/>
          <p:nvPr/>
        </p:nvSpPr>
        <p:spPr>
          <a:xfrm rot="18921849">
            <a:off x="8315312" y="1568742"/>
            <a:ext cx="15519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EXOSC9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53BE86E-7CD7-4D61-836E-C5F858BC0507}"/>
              </a:ext>
            </a:extLst>
          </p:cNvPr>
          <p:cNvSpPr txBox="1"/>
          <p:nvPr/>
        </p:nvSpPr>
        <p:spPr>
          <a:xfrm rot="18921849">
            <a:off x="8874617" y="1531400"/>
            <a:ext cx="15519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EXOSC9-L5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B300300-41E0-4BCC-8F9A-9D3618C12A1E}"/>
              </a:ext>
            </a:extLst>
          </p:cNvPr>
          <p:cNvSpPr txBox="1"/>
          <p:nvPr/>
        </p:nvSpPr>
        <p:spPr>
          <a:xfrm>
            <a:off x="4726394" y="3278776"/>
            <a:ext cx="1343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EXOSC9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0C2F5AC-2696-43C1-93CB-54F62F75942B}"/>
              </a:ext>
            </a:extLst>
          </p:cNvPr>
          <p:cNvSpPr txBox="1"/>
          <p:nvPr/>
        </p:nvSpPr>
        <p:spPr>
          <a:xfrm>
            <a:off x="10700753" y="2909444"/>
            <a:ext cx="10102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Karyo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3542D56-9331-4DEE-A106-A8AA731E9351}"/>
              </a:ext>
            </a:extLst>
          </p:cNvPr>
          <p:cNvSpPr txBox="1"/>
          <p:nvPr/>
        </p:nvSpPr>
        <p:spPr>
          <a:xfrm>
            <a:off x="10773973" y="4171396"/>
            <a:ext cx="792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p53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042038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58</Words>
  <Application>Microsoft Office PowerPoint</Application>
  <PresentationFormat>Widescreen</PresentationFormat>
  <Paragraphs>2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ita Horvath</dc:creator>
  <cp:lastModifiedBy>Claudia Schneider</cp:lastModifiedBy>
  <cp:revision>5</cp:revision>
  <dcterms:created xsi:type="dcterms:W3CDTF">2019-04-16T09:16:12Z</dcterms:created>
  <dcterms:modified xsi:type="dcterms:W3CDTF">2020-04-21T22:59:24Z</dcterms:modified>
</cp:coreProperties>
</file>